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D167C4-B014-46BC-8F75-6A67947CDA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88DD1-F593-4AC1-8306-786C514805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E5997-7266-4815-8CF7-F8B66DF1B2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2FDD1E-0B6D-48BA-837E-354F0A6DBE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AD0DB-58FC-4418-BC7B-EC52CD7927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B171B-0CE0-429E-927D-B49D83CF91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90CF3-8DF9-413D-98E3-B6DDE1F69A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A9BCC-5094-45A1-B351-7AD08F86A4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7A66F-416E-4853-B88B-055F4CEAC3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6117B6-1C9C-4B3F-A400-7C4D97D6B1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77B1D-2775-4798-A853-EE9EF5563E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DEE0C9-C1F4-4B19-8AB2-25DB37D11B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B1E0DE-FBCB-4E83-9546-8DF68CC5AC6A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9"/>
          <p:cNvSpPr/>
          <p:nvPr/>
        </p:nvSpPr>
        <p:spPr>
          <a:xfrm>
            <a:off x="501120" y="26496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1409760" y="417960"/>
            <a:ext cx="7275600" cy="233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-799920" rIns="90000" tIns="4680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mr_CEACAMa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TC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GCGGCAGCCA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T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G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AGG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-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T</a:t>
            </a:r>
            <a:r>
              <a:rPr b="1" lang="de-DE" sz="1000" spc="-1" strike="noStrike" u="sng">
                <a:solidFill>
                  <a:srgbClr val="ff0000"/>
                </a:solidFill>
                <a:uFillTx/>
                <a:latin typeface="Courier New"/>
                <a:ea typeface="Times New Roman"/>
              </a:rPr>
              <a:t>A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ml_CEACAMa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TC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GCTAGAGGCA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T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AGT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-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T</a:t>
            </a:r>
            <a:r>
              <a:rPr b="1" lang="de-DE" sz="1000" spc="-1" strike="noStrike" u="sng">
                <a:solidFill>
                  <a:srgbClr val="ff0000"/>
                </a:solidFill>
                <a:uFillTx/>
                <a:latin typeface="Courier New"/>
                <a:ea typeface="Times New Roman"/>
              </a:rPr>
              <a:t>A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Mmr_CEACAMb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TTT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GCTGGAGCCA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T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G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AGG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-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T</a:t>
            </a:r>
            <a:r>
              <a:rPr b="1" lang="de-DE" sz="1000" spc="-1" strike="noStrike" u="sng">
                <a:solidFill>
                  <a:srgbClr val="ff0000"/>
                </a:solidFill>
                <a:uFillTx/>
                <a:latin typeface="Courier New"/>
                <a:ea typeface="Times New Roman"/>
              </a:rPr>
              <a:t>A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tr_CEACAM8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TC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GCTAGGGCCA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AGG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-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T</a:t>
            </a:r>
            <a:r>
              <a:rPr b="1" lang="de-DE" sz="1000" spc="-1" strike="noStrike" u="sng">
                <a:solidFill>
                  <a:srgbClr val="ff0000"/>
                </a:solidFill>
                <a:uFillTx/>
                <a:latin typeface="Courier New"/>
                <a:ea typeface="Times New Roman"/>
              </a:rPr>
              <a:t>A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Hsa_CEACAM8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TC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GCTAGAGCCA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AGG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-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T</a:t>
            </a:r>
            <a:r>
              <a:rPr b="1" lang="de-DE" sz="1000" spc="-1" strike="noStrike" u="sng">
                <a:solidFill>
                  <a:srgbClr val="ff0000"/>
                </a:solidFill>
                <a:uFillTx/>
                <a:latin typeface="Courier New"/>
                <a:ea typeface="Times New Roman"/>
              </a:rPr>
              <a:t>A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Hsa_CEACAM6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TC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GCTGTGGCCA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AGG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-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T</a:t>
            </a:r>
            <a:r>
              <a:rPr b="1" lang="de-DE" sz="1000" spc="-1" strike="noStrike" u="sng">
                <a:solidFill>
                  <a:srgbClr val="ff0000"/>
                </a:solidFill>
                <a:uFillTx/>
                <a:latin typeface="Courier New"/>
                <a:ea typeface="Times New Roman"/>
              </a:rPr>
              <a:t>A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Ppy_CEACAM5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TC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GCTGCGGCCA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CAGA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-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T</a:t>
            </a:r>
            <a:r>
              <a:rPr b="1" lang="de-DE" sz="1000" spc="-1" strike="noStrike" u="sng">
                <a:solidFill>
                  <a:srgbClr val="ff0000"/>
                </a:solidFill>
                <a:uFillTx/>
                <a:latin typeface="Courier New"/>
                <a:ea typeface="Times New Roman"/>
              </a:rPr>
              <a:t>A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Hsa_CEACAM5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TC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T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GCTGGGGCCA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TGGG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-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T</a:t>
            </a:r>
            <a:r>
              <a:rPr b="1" lang="de-DE" sz="1000" spc="-1" strike="noStrike" u="sng">
                <a:solidFill>
                  <a:srgbClr val="ff0000"/>
                </a:solidFill>
                <a:uFillTx/>
                <a:latin typeface="Courier New"/>
                <a:ea typeface="Times New Roman"/>
              </a:rPr>
              <a:t>A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Hsa_CEACAM7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AC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GCTGGGACCG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C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TGG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-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T</a:t>
            </a:r>
            <a:r>
              <a:rPr b="1" lang="de-DE" sz="1000" spc="-1" strike="noStrike" u="sng">
                <a:solidFill>
                  <a:srgbClr val="ff0000"/>
                </a:solidFill>
                <a:uFillTx/>
                <a:latin typeface="Courier New"/>
                <a:ea typeface="Times New Roman"/>
              </a:rPr>
              <a:t>A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Times New Roman"/>
              </a:rPr>
              <a:t>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Ssc_CEACAMa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CTT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C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GATGGTGGTAT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T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TG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TGGG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G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GC---CTGGTG</a:t>
            </a:r>
            <a:r>
              <a:rPr b="1" lang="de-DE" sz="1000" spc="-1" strike="noStrike" u="sng">
                <a:solidFill>
                  <a:srgbClr val="000000"/>
                </a:solidFill>
                <a:uFillTx/>
                <a:latin typeface="Courier New"/>
                <a:ea typeface="Arial Unicode MS"/>
              </a:rPr>
              <a:t>TA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ge_CEACAMa                            CA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TC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A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TGGG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G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CC---CTGGTG</a:t>
            </a:r>
            <a:r>
              <a:rPr b="0" lang="de-DE" sz="1000" spc="-1" strike="noStrike" u="sng">
                <a:solidFill>
                  <a:srgbClr val="000000"/>
                </a:solidFill>
                <a:uFillTx/>
                <a:latin typeface="Courier New"/>
                <a:ea typeface="Arial Unicode MS"/>
              </a:rPr>
              <a:t>TA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mo_CEACAMa              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GCTGGGACCA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TC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A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G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TGGC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G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CC---CTGATG</a:t>
            </a:r>
            <a:r>
              <a:rPr b="0" lang="de-DE" sz="1000" spc="-1" strike="noStrike" u="sng">
                <a:solidFill>
                  <a:srgbClr val="000000"/>
                </a:solidFill>
                <a:uFillTx/>
                <a:latin typeface="Courier New"/>
                <a:ea typeface="Arial Unicode MS"/>
              </a:rPr>
              <a:t>TA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           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 Unicode MS"/>
              </a:rPr>
              <a:t> 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Hsa_CEACAM1 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A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------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C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CTC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CCTGGGGCCAT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T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C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TG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A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GAG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CCTGG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GC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A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T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AGC</a:t>
            </a:r>
            <a:r>
              <a:rPr b="0" lang="de-DE" sz="1000" spc="-1" strike="noStrike">
                <a:solidFill>
                  <a:srgbClr val="ff0000"/>
                </a:solidFill>
                <a:latin typeface="Courier New"/>
                <a:ea typeface="Arial Unicode MS"/>
              </a:rPr>
              <a:t>A</a:t>
            </a:r>
            <a:r>
              <a:rPr b="0" lang="de-DE" sz="1000" spc="-1" strike="noStrike">
                <a:solidFill>
                  <a:srgbClr val="000000"/>
                </a:solidFill>
                <a:latin typeface="Courier New"/>
                <a:ea typeface="Arial Unicode MS"/>
              </a:rPr>
              <a:t>GTAGCCCTGGCATGT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49"/>
          <p:cNvSpPr/>
          <p:nvPr/>
        </p:nvSpPr>
        <p:spPr>
          <a:xfrm>
            <a:off x="568800" y="6323040"/>
            <a:ext cx="163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23"/>
          <p:cNvGrpSpPr/>
          <p:nvPr/>
        </p:nvGrpSpPr>
        <p:grpSpPr>
          <a:xfrm>
            <a:off x="501120" y="2679840"/>
            <a:ext cx="6387840" cy="677520"/>
            <a:chOff x="501120" y="2679840"/>
            <a:chExt cx="6387840" cy="677520"/>
          </a:xfrm>
        </p:grpSpPr>
        <p:sp>
          <p:nvSpPr>
            <p:cNvPr id="45" name="Rectangle 6"/>
            <p:cNvSpPr/>
            <p:nvPr/>
          </p:nvSpPr>
          <p:spPr>
            <a:xfrm>
              <a:off x="723240" y="3006000"/>
              <a:ext cx="6165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 Unicode MS"/>
                </a:rPr>
                <a:t>Ssc_CEACAMa  …..REDAGNYQCEASNPGNSSLSDPLRLDVKFDSIPGSTSGV</a:t>
              </a:r>
              <a:r>
                <a:rPr b="1" lang="de-DE" sz="1000" spc="-1" strike="noStrike" u="sng">
                  <a:solidFill>
                    <a:srgbClr val="ff9933"/>
                  </a:solidFill>
                  <a:uFillTx/>
                  <a:latin typeface="Arial Unicode MS"/>
                </a:rPr>
                <a:t>S</a:t>
              </a:r>
              <a:r>
                <a:rPr b="1" lang="de-DE" sz="1000" spc="-1" strike="noStrike" u="sng">
                  <a:solidFill>
                    <a:srgbClr val="ff0000"/>
                  </a:solidFill>
                  <a:uFillTx/>
                  <a:latin typeface="Arial Unicode MS"/>
                </a:rPr>
                <a:t>D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 Unicode MS"/>
                </a:rPr>
                <a:t>GGIAGIVIGVLAGVALIAG LV 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49"/>
            <p:cNvSpPr/>
            <p:nvPr/>
          </p:nvSpPr>
          <p:spPr>
            <a:xfrm>
              <a:off x="501120" y="2679840"/>
              <a:ext cx="31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7" name="Gerade Verbindung mit Pfeil 12"/>
            <p:cNvCxnSpPr/>
            <p:nvPr/>
          </p:nvCxnSpPr>
          <p:spPr>
            <a:xfrm flipV="1">
              <a:off x="5300640" y="3214080"/>
              <a:ext cx="2160" cy="143640"/>
            </a:xfrm>
            <a:prstGeom prst="straightConnector1">
              <a:avLst/>
            </a:prstGeom>
            <a:ln w="9360">
              <a:solidFill>
                <a:srgbClr val="ff0000"/>
              </a:solidFill>
              <a:miter/>
              <a:tailEnd len="med" type="arrow" w="med"/>
            </a:ln>
          </p:spPr>
        </p:cxnSp>
        <p:cxnSp>
          <p:nvCxnSpPr>
            <p:cNvPr id="48" name="Gerade Verbindung mit Pfeil 13"/>
            <p:cNvCxnSpPr/>
            <p:nvPr/>
          </p:nvCxnSpPr>
          <p:spPr>
            <a:xfrm flipV="1">
              <a:off x="5178600" y="3214080"/>
              <a:ext cx="2160" cy="143640"/>
            </a:xfrm>
            <a:prstGeom prst="straightConnector1">
              <a:avLst/>
            </a:prstGeom>
            <a:ln w="9360">
              <a:solidFill>
                <a:srgbClr val="ffc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20T15:28:30Z</dcterms:created>
  <dc:creator>ZIMMERMANN</dc:creator>
  <dc:description/>
  <dc:language>en-US</dc:language>
  <cp:lastModifiedBy>robert.kammerer</cp:lastModifiedBy>
  <dcterms:modified xsi:type="dcterms:W3CDTF">2010-02-23T13:25:23Z</dcterms:modified>
  <cp:revision>165</cp:revision>
  <dc:subject/>
  <dc:title>Folie 1</dc:title>
</cp:coreProperties>
</file>